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24" r:id="rId2"/>
  </p:sldIdLst>
  <p:sldSz cx="9601200" cy="12801600" type="A3"/>
  <p:notesSz cx="6858000" cy="9144000"/>
  <p:defaultTextStyle>
    <a:defPPr>
      <a:defRPr lang="en-US"/>
    </a:defPPr>
    <a:lvl1pPr marL="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 userDrawn="1">
          <p15:clr>
            <a:srgbClr val="A4A3A4"/>
          </p15:clr>
        </p15:guide>
        <p15:guide id="2" pos="30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300"/>
    <a:srgbClr val="0432FF"/>
    <a:srgbClr val="FF0100"/>
    <a:srgbClr val="FF9700"/>
    <a:srgbClr val="FEFF1C"/>
    <a:srgbClr val="FFB502"/>
    <a:srgbClr val="FFD302"/>
    <a:srgbClr val="FCB301"/>
    <a:srgbClr val="F69102"/>
    <a:srgbClr val="FFFF1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13"/>
    <p:restoredTop sz="95161"/>
  </p:normalViewPr>
  <p:slideViewPr>
    <p:cSldViewPr snapToGrid="0" snapToObjects="1">
      <p:cViewPr varScale="1">
        <p:scale>
          <a:sx n="55" d="100"/>
          <a:sy n="55" d="100"/>
        </p:scale>
        <p:origin x="3144" y="192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SPS%20Postdoc/August%202021/Research/Moneymaker/5-AZA%20II/Fruit%20firmnes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400992238738655"/>
          <c:y val="6.6865296060846999E-2"/>
          <c:w val="0.80348411102550132"/>
          <c:h val="0.8948443207248217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L$5:$L$8</c:f>
                <c:numCache>
                  <c:formatCode>General</c:formatCode>
                  <c:ptCount val="4"/>
                  <c:pt idx="0">
                    <c:v>1.0224407978876715</c:v>
                  </c:pt>
                  <c:pt idx="2">
                    <c:v>0.19878799427195476</c:v>
                  </c:pt>
                  <c:pt idx="3">
                    <c:v>0.70827385371186047</c:v>
                  </c:pt>
                </c:numCache>
              </c:numRef>
            </c:plus>
            <c:minus>
              <c:numRef>
                <c:f>Sheet1!$L$5:$L$8</c:f>
                <c:numCache>
                  <c:formatCode>General</c:formatCode>
                  <c:ptCount val="4"/>
                  <c:pt idx="0">
                    <c:v>1.0224407978876715</c:v>
                  </c:pt>
                  <c:pt idx="2">
                    <c:v>0.19878799427195476</c:v>
                  </c:pt>
                  <c:pt idx="3">
                    <c:v>0.70827385371186047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Sheet1!$I$5:$J$8</c:f>
              <c:multiLvlStrCache>
                <c:ptCount val="4"/>
                <c:lvl>
                  <c:pt idx="0">
                    <c:v>At-harvest</c:v>
                  </c:pt>
                  <c:pt idx="2">
                    <c:v>Mock</c:v>
                  </c:pt>
                  <c:pt idx="3">
                    <c:v>5-AZA</c:v>
                  </c:pt>
                </c:lvl>
                <c:lvl>
                  <c:pt idx="0">
                    <c:v>0 d</c:v>
                  </c:pt>
                  <c:pt idx="2">
                    <c:v>storage</c:v>
                  </c:pt>
                </c:lvl>
              </c:multiLvlStrCache>
            </c:multiLvlStrRef>
          </c:cat>
          <c:val>
            <c:numRef>
              <c:f>Sheet1!$K$5:$K$8</c:f>
              <c:numCache>
                <c:formatCode>General</c:formatCode>
                <c:ptCount val="4"/>
                <c:pt idx="0" formatCode="0.00">
                  <c:v>14.721666666666669</c:v>
                </c:pt>
                <c:pt idx="2" formatCode="0.00">
                  <c:v>7.7450000000000001</c:v>
                </c:pt>
                <c:pt idx="3" formatCode="0.00">
                  <c:v>11.21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7C-A444-ADD7-FD6D877D32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27"/>
        <c:axId val="353234703"/>
        <c:axId val="376267439"/>
      </c:barChart>
      <c:catAx>
        <c:axId val="3532347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376267439"/>
        <c:crosses val="autoZero"/>
        <c:auto val="1"/>
        <c:lblAlgn val="ctr"/>
        <c:lblOffset val="100"/>
        <c:noMultiLvlLbl val="0"/>
      </c:catAx>
      <c:valAx>
        <c:axId val="376267439"/>
        <c:scaling>
          <c:orientation val="minMax"/>
          <c:max val="18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353234703"/>
        <c:crosses val="autoZero"/>
        <c:crossBetween val="between"/>
        <c:majorUnit val="3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82A022-C9F4-0148-975C-F94539B6FB3D}" type="datetimeFigureOut">
              <a:rPr lang="en-US" smtClean="0"/>
              <a:t>7/12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5F2F5C-3AD8-114A-9235-54C4AB861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9318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473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D6563BDF-976A-87E1-5321-26BA10DFFB2A}"/>
              </a:ext>
            </a:extLst>
          </p:cNvPr>
          <p:cNvGrpSpPr/>
          <p:nvPr/>
        </p:nvGrpSpPr>
        <p:grpSpPr>
          <a:xfrm>
            <a:off x="3235751" y="1694986"/>
            <a:ext cx="3254259" cy="3405306"/>
            <a:chOff x="4418245" y="868371"/>
            <a:chExt cx="3254259" cy="3405306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56491335-125F-1532-0CEC-020D5110B511}"/>
                </a:ext>
              </a:extLst>
            </p:cNvPr>
            <p:cNvGrpSpPr/>
            <p:nvPr/>
          </p:nvGrpSpPr>
          <p:grpSpPr>
            <a:xfrm>
              <a:off x="4765675" y="868371"/>
              <a:ext cx="2906829" cy="3405306"/>
              <a:chOff x="4765675" y="868371"/>
              <a:chExt cx="2906829" cy="3405306"/>
            </a:xfrm>
          </p:grpSpPr>
          <p:graphicFrame>
            <p:nvGraphicFramePr>
              <p:cNvPr id="12" name="Chart 11">
                <a:extLst>
                  <a:ext uri="{FF2B5EF4-FFF2-40B4-BE49-F238E27FC236}">
                    <a16:creationId xmlns:a16="http://schemas.microsoft.com/office/drawing/2014/main" id="{28142BEE-16A6-6FE5-F253-2B030F63CE9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657003565"/>
                  </p:ext>
                </p:extLst>
              </p:nvPr>
            </p:nvGraphicFramePr>
            <p:xfrm>
              <a:off x="4765675" y="868371"/>
              <a:ext cx="2660650" cy="222222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57FACF8-A7AF-C52E-F1EF-C91A35232EFE}"/>
                  </a:ext>
                </a:extLst>
              </p:cNvPr>
              <p:cNvSpPr txBox="1"/>
              <p:nvPr/>
            </p:nvSpPr>
            <p:spPr>
              <a:xfrm rot="17474067">
                <a:off x="4846698" y="3229338"/>
                <a:ext cx="89125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t-harvest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FBD8D45A-6366-126D-4E71-D466E837C77C}"/>
                  </a:ext>
                </a:extLst>
              </p:cNvPr>
              <p:cNvSpPr txBox="1"/>
              <p:nvPr/>
            </p:nvSpPr>
            <p:spPr>
              <a:xfrm rot="17474067">
                <a:off x="6141302" y="3100744"/>
                <a:ext cx="5467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0CBBEF07-4F3E-2271-0A02-DFA8E610DBF5}"/>
                  </a:ext>
                </a:extLst>
              </p:cNvPr>
              <p:cNvSpPr txBox="1"/>
              <p:nvPr/>
            </p:nvSpPr>
            <p:spPr>
              <a:xfrm rot="17474067">
                <a:off x="6298230" y="3335961"/>
                <a:ext cx="112003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-Azacytidine</a:t>
                </a:r>
              </a:p>
            </p:txBody>
          </p: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8455E506-ACA5-1039-14C8-CC17BC7B7D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37681" y="3977168"/>
                <a:ext cx="105437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FC7815C0-0ACE-EAE4-31AE-0AF51144F19F}"/>
                  </a:ext>
                </a:extLst>
              </p:cNvPr>
              <p:cNvSpPr txBox="1"/>
              <p:nvPr/>
            </p:nvSpPr>
            <p:spPr>
              <a:xfrm>
                <a:off x="5899460" y="3996678"/>
                <a:ext cx="177304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4 d at 5ºC→7 d 20ºC</a:t>
                </a:r>
              </a:p>
            </p:txBody>
          </p: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557DBFB-AB17-1F63-AEBB-7E54AD18E4CC}"/>
                </a:ext>
              </a:extLst>
            </p:cNvPr>
            <p:cNvSpPr txBox="1"/>
            <p:nvPr/>
          </p:nvSpPr>
          <p:spPr>
            <a:xfrm rot="16200000">
              <a:off x="3719356" y="1689923"/>
              <a:ext cx="1815906" cy="4181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JP" dirty="0">
                  <a:latin typeface="Arial" panose="020B0604020202020204" pitchFamily="34" charset="0"/>
                  <a:cs typeface="Arial" panose="020B0604020202020204" pitchFamily="34" charset="0"/>
                </a:rPr>
                <a:t>Firmness (N)</a:t>
              </a:r>
            </a:p>
          </p:txBody>
        </p: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6FB0FE58-CE8C-3132-BA25-1619F4FFED49}"/>
                </a:ext>
              </a:extLst>
            </p:cNvPr>
            <p:cNvCxnSpPr/>
            <p:nvPr/>
          </p:nvCxnSpPr>
          <p:spPr>
            <a:xfrm>
              <a:off x="6322084" y="1579948"/>
              <a:ext cx="0" cy="57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DE6B0EBE-4CC8-B8B3-4C45-4861CB6D8602}"/>
                </a:ext>
              </a:extLst>
            </p:cNvPr>
            <p:cNvCxnSpPr/>
            <p:nvPr/>
          </p:nvCxnSpPr>
          <p:spPr>
            <a:xfrm>
              <a:off x="6860174" y="1579948"/>
              <a:ext cx="0" cy="18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01E0111B-8AE2-F5D6-FA7D-C84601176C21}"/>
                </a:ext>
              </a:extLst>
            </p:cNvPr>
            <p:cNvCxnSpPr>
              <a:cxnSpLocks/>
            </p:cNvCxnSpPr>
            <p:nvPr/>
          </p:nvCxnSpPr>
          <p:spPr>
            <a:xfrm>
              <a:off x="6322084" y="1579948"/>
              <a:ext cx="5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63A7AE6-3B96-6363-8D02-A5BD319E9B0D}"/>
                </a:ext>
              </a:extLst>
            </p:cNvPr>
            <p:cNvSpPr txBox="1"/>
            <p:nvPr/>
          </p:nvSpPr>
          <p:spPr>
            <a:xfrm>
              <a:off x="6330282" y="1368837"/>
              <a:ext cx="347240" cy="369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JP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5E5FD43E-71ED-600A-12ED-2DE3F3FA23B0}"/>
              </a:ext>
            </a:extLst>
          </p:cNvPr>
          <p:cNvSpPr txBox="1"/>
          <p:nvPr/>
        </p:nvSpPr>
        <p:spPr>
          <a:xfrm>
            <a:off x="403507" y="5321799"/>
            <a:ext cx="91976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Effect of 5-azacytidine on pericarp firmness of “Moneymaker” fruits during post-cold storage handling at 20ºC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ach datapoint represents the average (± SE) of 10 fruits. * indicates a significant difference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).</a:t>
            </a:r>
          </a:p>
        </p:txBody>
      </p:sp>
    </p:spTree>
    <p:extLst>
      <p:ext uri="{BB962C8B-B14F-4D97-AF65-F5344CB8AC3E}">
        <p14:creationId xmlns:p14="http://schemas.microsoft.com/office/powerpoint/2010/main" val="950411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9648</TotalTime>
  <Words>60</Words>
  <Application>Microsoft Macintosh PowerPoint</Application>
  <PresentationFormat>A3 Paper (297x420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TALO Oscar　Witere</dc:creator>
  <cp:keywords/>
  <dc:description/>
  <cp:lastModifiedBy>Oscar Witere Mitalo</cp:lastModifiedBy>
  <cp:revision>1664</cp:revision>
  <cp:lastPrinted>2022-02-28T04:45:31Z</cp:lastPrinted>
  <dcterms:created xsi:type="dcterms:W3CDTF">2018-04-12T04:09:11Z</dcterms:created>
  <dcterms:modified xsi:type="dcterms:W3CDTF">2023-07-11T15:16:27Z</dcterms:modified>
  <cp:category/>
</cp:coreProperties>
</file>